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6" r:id="rId3"/>
    <p:sldId id="260" r:id="rId4"/>
    <p:sldId id="257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3" d="100"/>
          <a:sy n="83" d="100"/>
        </p:scale>
        <p:origin x="299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05868-F396-4D25-9916-578C48F44263}" type="datetimeFigureOut">
              <a:rPr lang="en-GB" smtClean="0"/>
              <a:t>01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4EFE5-CC70-4918-9C6D-7357540C80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3350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05868-F396-4D25-9916-578C48F44263}" type="datetimeFigureOut">
              <a:rPr lang="en-GB" smtClean="0"/>
              <a:t>01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4EFE5-CC70-4918-9C6D-7357540C80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83263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05868-F396-4D25-9916-578C48F44263}" type="datetimeFigureOut">
              <a:rPr lang="en-GB" smtClean="0"/>
              <a:t>01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4EFE5-CC70-4918-9C6D-7357540C80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21604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05868-F396-4D25-9916-578C48F44263}" type="datetimeFigureOut">
              <a:rPr lang="en-GB" smtClean="0"/>
              <a:t>01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4EFE5-CC70-4918-9C6D-7357540C80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4519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05868-F396-4D25-9916-578C48F44263}" type="datetimeFigureOut">
              <a:rPr lang="en-GB" smtClean="0"/>
              <a:t>01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4EFE5-CC70-4918-9C6D-7357540C80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60857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05868-F396-4D25-9916-578C48F44263}" type="datetimeFigureOut">
              <a:rPr lang="en-GB" smtClean="0"/>
              <a:t>01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4EFE5-CC70-4918-9C6D-7357540C80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4848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05868-F396-4D25-9916-578C48F44263}" type="datetimeFigureOut">
              <a:rPr lang="en-GB" smtClean="0"/>
              <a:t>01/11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4EFE5-CC70-4918-9C6D-7357540C80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2516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05868-F396-4D25-9916-578C48F44263}" type="datetimeFigureOut">
              <a:rPr lang="en-GB" smtClean="0"/>
              <a:t>01/11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4EFE5-CC70-4918-9C6D-7357540C80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2540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05868-F396-4D25-9916-578C48F44263}" type="datetimeFigureOut">
              <a:rPr lang="en-GB" smtClean="0"/>
              <a:t>01/11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4EFE5-CC70-4918-9C6D-7357540C80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29134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05868-F396-4D25-9916-578C48F44263}" type="datetimeFigureOut">
              <a:rPr lang="en-GB" smtClean="0"/>
              <a:t>01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4EFE5-CC70-4918-9C6D-7357540C80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345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05868-F396-4D25-9916-578C48F44263}" type="datetimeFigureOut">
              <a:rPr lang="en-GB" smtClean="0"/>
              <a:t>01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4EFE5-CC70-4918-9C6D-7357540C80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51199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205868-F396-4D25-9916-578C48F44263}" type="datetimeFigureOut">
              <a:rPr lang="en-GB" smtClean="0"/>
              <a:t>01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74EFE5-CC70-4918-9C6D-7357540C80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10621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tiff"/><Relationship Id="rId5" Type="http://schemas.openxmlformats.org/officeDocument/2006/relationships/image" Target="../media/image20.tiff"/><Relationship Id="rId4" Type="http://schemas.openxmlformats.org/officeDocument/2006/relationships/image" Target="../media/image1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60878" y="382291"/>
            <a:ext cx="4452505" cy="36933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3091971"/>
              </p:ext>
            </p:extLst>
          </p:nvPr>
        </p:nvGraphicFramePr>
        <p:xfrm>
          <a:off x="349012" y="936182"/>
          <a:ext cx="6144390" cy="1854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77770">
                  <a:extLst>
                    <a:ext uri="{9D8B030D-6E8A-4147-A177-3AD203B41FA5}">
                      <a16:colId xmlns:a16="http://schemas.microsoft.com/office/drawing/2014/main" val="2270496956"/>
                    </a:ext>
                  </a:extLst>
                </a:gridCol>
                <a:gridCol w="877770">
                  <a:extLst>
                    <a:ext uri="{9D8B030D-6E8A-4147-A177-3AD203B41FA5}">
                      <a16:colId xmlns:a16="http://schemas.microsoft.com/office/drawing/2014/main" val="2821553154"/>
                    </a:ext>
                  </a:extLst>
                </a:gridCol>
                <a:gridCol w="877770">
                  <a:extLst>
                    <a:ext uri="{9D8B030D-6E8A-4147-A177-3AD203B41FA5}">
                      <a16:colId xmlns:a16="http://schemas.microsoft.com/office/drawing/2014/main" val="3592044187"/>
                    </a:ext>
                  </a:extLst>
                </a:gridCol>
                <a:gridCol w="877770">
                  <a:extLst>
                    <a:ext uri="{9D8B030D-6E8A-4147-A177-3AD203B41FA5}">
                      <a16:colId xmlns:a16="http://schemas.microsoft.com/office/drawing/2014/main" val="1194234167"/>
                    </a:ext>
                  </a:extLst>
                </a:gridCol>
                <a:gridCol w="877770">
                  <a:extLst>
                    <a:ext uri="{9D8B030D-6E8A-4147-A177-3AD203B41FA5}">
                      <a16:colId xmlns:a16="http://schemas.microsoft.com/office/drawing/2014/main" val="2925829836"/>
                    </a:ext>
                  </a:extLst>
                </a:gridCol>
                <a:gridCol w="877770">
                  <a:extLst>
                    <a:ext uri="{9D8B030D-6E8A-4147-A177-3AD203B41FA5}">
                      <a16:colId xmlns:a16="http://schemas.microsoft.com/office/drawing/2014/main" val="583609275"/>
                    </a:ext>
                  </a:extLst>
                </a:gridCol>
                <a:gridCol w="877770">
                  <a:extLst>
                    <a:ext uri="{9D8B030D-6E8A-4147-A177-3AD203B41FA5}">
                      <a16:colId xmlns:a16="http://schemas.microsoft.com/office/drawing/2014/main" val="407005376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fibrotic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8937160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3874047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8425584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1 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1246587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VC 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4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40144248"/>
                  </a:ext>
                </a:extLst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5575041"/>
              </p:ext>
            </p:extLst>
          </p:nvPr>
        </p:nvGraphicFramePr>
        <p:xfrm>
          <a:off x="349012" y="3085940"/>
          <a:ext cx="6144391" cy="466273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15995">
                  <a:extLst>
                    <a:ext uri="{9D8B030D-6E8A-4147-A177-3AD203B41FA5}">
                      <a16:colId xmlns:a16="http://schemas.microsoft.com/office/drawing/2014/main" val="2270496956"/>
                    </a:ext>
                  </a:extLst>
                </a:gridCol>
                <a:gridCol w="401167">
                  <a:extLst>
                    <a:ext uri="{9D8B030D-6E8A-4147-A177-3AD203B41FA5}">
                      <a16:colId xmlns:a16="http://schemas.microsoft.com/office/drawing/2014/main" val="2821553154"/>
                    </a:ext>
                  </a:extLst>
                </a:gridCol>
                <a:gridCol w="558581">
                  <a:extLst>
                    <a:ext uri="{9D8B030D-6E8A-4147-A177-3AD203B41FA5}">
                      <a16:colId xmlns:a16="http://schemas.microsoft.com/office/drawing/2014/main" val="3592044187"/>
                    </a:ext>
                  </a:extLst>
                </a:gridCol>
                <a:gridCol w="558581">
                  <a:extLst>
                    <a:ext uri="{9D8B030D-6E8A-4147-A177-3AD203B41FA5}">
                      <a16:colId xmlns:a16="http://schemas.microsoft.com/office/drawing/2014/main" val="1194234167"/>
                    </a:ext>
                  </a:extLst>
                </a:gridCol>
                <a:gridCol w="558581">
                  <a:extLst>
                    <a:ext uri="{9D8B030D-6E8A-4147-A177-3AD203B41FA5}">
                      <a16:colId xmlns:a16="http://schemas.microsoft.com/office/drawing/2014/main" val="2925829836"/>
                    </a:ext>
                  </a:extLst>
                </a:gridCol>
                <a:gridCol w="558581">
                  <a:extLst>
                    <a:ext uri="{9D8B030D-6E8A-4147-A177-3AD203B41FA5}">
                      <a16:colId xmlns:a16="http://schemas.microsoft.com/office/drawing/2014/main" val="583609275"/>
                    </a:ext>
                  </a:extLst>
                </a:gridCol>
                <a:gridCol w="558581">
                  <a:extLst>
                    <a:ext uri="{9D8B030D-6E8A-4147-A177-3AD203B41FA5}">
                      <a16:colId xmlns:a16="http://schemas.microsoft.com/office/drawing/2014/main" val="4070053769"/>
                    </a:ext>
                  </a:extLst>
                </a:gridCol>
                <a:gridCol w="558581">
                  <a:extLst>
                    <a:ext uri="{9D8B030D-6E8A-4147-A177-3AD203B41FA5}">
                      <a16:colId xmlns:a16="http://schemas.microsoft.com/office/drawing/2014/main" val="2883889448"/>
                    </a:ext>
                  </a:extLst>
                </a:gridCol>
                <a:gridCol w="558581">
                  <a:extLst>
                    <a:ext uri="{9D8B030D-6E8A-4147-A177-3AD203B41FA5}">
                      <a16:colId xmlns:a16="http://schemas.microsoft.com/office/drawing/2014/main" val="1886620859"/>
                    </a:ext>
                  </a:extLst>
                </a:gridCol>
                <a:gridCol w="558581">
                  <a:extLst>
                    <a:ext uri="{9D8B030D-6E8A-4147-A177-3AD203B41FA5}">
                      <a16:colId xmlns:a16="http://schemas.microsoft.com/office/drawing/2014/main" val="1712269410"/>
                    </a:ext>
                  </a:extLst>
                </a:gridCol>
                <a:gridCol w="558581">
                  <a:extLst>
                    <a:ext uri="{9D8B030D-6E8A-4147-A177-3AD203B41FA5}">
                      <a16:colId xmlns:a16="http://schemas.microsoft.com/office/drawing/2014/main" val="3583911128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brotic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8937160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ge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4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9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2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5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1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5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2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5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1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33874047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ex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58425584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EV1 %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8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7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1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4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9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7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6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7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91246587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VC %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3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9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3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6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4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2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1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2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1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4014424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LCO %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3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2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4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2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2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3148258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adiology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typical UI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I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SI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I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I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SI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I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IP atypical PF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SI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SIP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414975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thology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I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IP with granulomas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I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I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I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I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I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I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I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IP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06347297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linical diagnosis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PF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arcoidosis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PF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PF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PF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PF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PF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typical</a:t>
                      </a:r>
                      <a:r>
                        <a:rPr lang="en-GB" sz="90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PF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SI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SIP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09889327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rednisolone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15854451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irfenidone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71541746"/>
                  </a:ext>
                </a:extLst>
              </a:tr>
              <a:tr h="36505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intedanib</a:t>
                      </a:r>
                      <a:endParaRPr lang="en-GB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08278207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7C2CAF93-D2EC-4DE0-B9EA-F151C1D75407}"/>
              </a:ext>
            </a:extLst>
          </p:cNvPr>
          <p:cNvSpPr txBox="1"/>
          <p:nvPr/>
        </p:nvSpPr>
        <p:spPr>
          <a:xfrm>
            <a:off x="316393" y="8059043"/>
            <a:ext cx="62096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Patient Demographics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Non-fibrotic and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fibrotic patient demographics. Lung function for fibrotic patients were taken as the last pulmonary function reading before transplant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A29B487-0EBF-417D-BA87-343AAE3229FC}"/>
              </a:ext>
            </a:extLst>
          </p:cNvPr>
          <p:cNvSpPr txBox="1"/>
          <p:nvPr/>
        </p:nvSpPr>
        <p:spPr>
          <a:xfrm>
            <a:off x="221691" y="659183"/>
            <a:ext cx="4140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A29B487-0EBF-417D-BA87-343AAE3229FC}"/>
              </a:ext>
            </a:extLst>
          </p:cNvPr>
          <p:cNvSpPr txBox="1"/>
          <p:nvPr/>
        </p:nvSpPr>
        <p:spPr>
          <a:xfrm>
            <a:off x="221690" y="2831022"/>
            <a:ext cx="4140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12802822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60878" y="382291"/>
            <a:ext cx="4452505" cy="36933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8489676"/>
              </p:ext>
            </p:extLst>
          </p:nvPr>
        </p:nvGraphicFramePr>
        <p:xfrm>
          <a:off x="572879" y="904600"/>
          <a:ext cx="5695719" cy="334200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78060">
                  <a:extLst>
                    <a:ext uri="{9D8B030D-6E8A-4147-A177-3AD203B41FA5}">
                      <a16:colId xmlns:a16="http://schemas.microsoft.com/office/drawing/2014/main" val="2270496956"/>
                    </a:ext>
                  </a:extLst>
                </a:gridCol>
                <a:gridCol w="908367">
                  <a:extLst>
                    <a:ext uri="{9D8B030D-6E8A-4147-A177-3AD203B41FA5}">
                      <a16:colId xmlns:a16="http://schemas.microsoft.com/office/drawing/2014/main" val="2821553154"/>
                    </a:ext>
                  </a:extLst>
                </a:gridCol>
                <a:gridCol w="854596">
                  <a:extLst>
                    <a:ext uri="{9D8B030D-6E8A-4147-A177-3AD203B41FA5}">
                      <a16:colId xmlns:a16="http://schemas.microsoft.com/office/drawing/2014/main" val="3592044187"/>
                    </a:ext>
                  </a:extLst>
                </a:gridCol>
                <a:gridCol w="813674">
                  <a:extLst>
                    <a:ext uri="{9D8B030D-6E8A-4147-A177-3AD203B41FA5}">
                      <a16:colId xmlns:a16="http://schemas.microsoft.com/office/drawing/2014/main" val="1194234167"/>
                    </a:ext>
                  </a:extLst>
                </a:gridCol>
                <a:gridCol w="813674">
                  <a:extLst>
                    <a:ext uri="{9D8B030D-6E8A-4147-A177-3AD203B41FA5}">
                      <a16:colId xmlns:a16="http://schemas.microsoft.com/office/drawing/2014/main" val="2925829836"/>
                    </a:ext>
                  </a:extLst>
                </a:gridCol>
                <a:gridCol w="813674">
                  <a:extLst>
                    <a:ext uri="{9D8B030D-6E8A-4147-A177-3AD203B41FA5}">
                      <a16:colId xmlns:a16="http://schemas.microsoft.com/office/drawing/2014/main" val="583609275"/>
                    </a:ext>
                  </a:extLst>
                </a:gridCol>
                <a:gridCol w="813674">
                  <a:extLst>
                    <a:ext uri="{9D8B030D-6E8A-4147-A177-3AD203B41FA5}">
                      <a16:colId xmlns:a16="http://schemas.microsoft.com/office/drawing/2014/main" val="407005376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cinous Adeno.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8937160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ge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7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7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4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9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3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33874047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ex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58425584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EV%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3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5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2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58095561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VC%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2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43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3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0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1677002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LCO%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4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8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4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0937798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thology Diagnosis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ucinous adenocarcinoma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enocarcinoma, predominantly acinar, mucinous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enocarcinoma, predominantly </a:t>
                      </a:r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pidic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mucinous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enocarcinoma, predominantly </a:t>
                      </a:r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pidic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mucinous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enocarcinoma, predominantly </a:t>
                      </a:r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pidic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mucinous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enocarcinoma, pattern, mucinous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6347297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taging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pT3,  ypN0, ypM1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3   pN0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endParaRPr lang="en-GB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1b  pN0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1a       pN0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2b pN0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3       pN0 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09889327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reatment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eoadjuvant</a:t>
                      </a: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hemotherapy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158544516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7C2CAF93-D2EC-4DE0-B9EA-F151C1D75407}"/>
              </a:ext>
            </a:extLst>
          </p:cNvPr>
          <p:cNvSpPr txBox="1"/>
          <p:nvPr/>
        </p:nvSpPr>
        <p:spPr>
          <a:xfrm>
            <a:off x="315924" y="4502224"/>
            <a:ext cx="62096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: Mucinous adenocarcinoma patient demographics.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88041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DD6AA240-344C-0AD9-FDB9-886D8E46C973}"/>
              </a:ext>
            </a:extLst>
          </p:cNvPr>
          <p:cNvSpPr txBox="1"/>
          <p:nvPr/>
        </p:nvSpPr>
        <p:spPr>
          <a:xfrm>
            <a:off x="567961" y="807063"/>
            <a:ext cx="1356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entachrome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BBBB0FA-8C90-77AD-2589-0B5139B96ECC}"/>
              </a:ext>
            </a:extLst>
          </p:cNvPr>
          <p:cNvSpPr txBox="1"/>
          <p:nvPr/>
        </p:nvSpPr>
        <p:spPr>
          <a:xfrm>
            <a:off x="1160878" y="382291"/>
            <a:ext cx="4452505" cy="36933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C7B86C7-E31B-130B-FDF0-2615BDCCB20E}"/>
              </a:ext>
            </a:extLst>
          </p:cNvPr>
          <p:cNvSpPr txBox="1"/>
          <p:nvPr/>
        </p:nvSpPr>
        <p:spPr>
          <a:xfrm>
            <a:off x="261139" y="1024572"/>
            <a:ext cx="3622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407721" y="5568893"/>
            <a:ext cx="5866064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. Elastin disorganization in the fibrotic honeycomb airway. </a:t>
            </a:r>
            <a:r>
              <a:rPr lang="en-GB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n-fibrotic and 4 fibrotic specimens were stained for pentachrome or </a:t>
            </a:r>
            <a:r>
              <a:rPr lang="en-GB" sz="10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munostained</a:t>
            </a:r>
            <a:r>
              <a:rPr lang="en-GB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or elastin. Shown are representative images for (</a:t>
            </a:r>
            <a:r>
              <a:rPr lang="en-GB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non-fibrotic airway, (</a:t>
            </a:r>
            <a:r>
              <a:rPr lang="en-GB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fibrotic uninvolved airways, and (</a:t>
            </a:r>
            <a:r>
              <a:rPr lang="en-GB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fibrotic honeycomb airways. Note that elastin fibres (black in </a:t>
            </a:r>
            <a:r>
              <a:rPr lang="en-GB" sz="10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lor</a:t>
            </a:r>
            <a:r>
              <a:rPr lang="en-GB" sz="10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the pentachrome) surround airways in the non-fibrotic airway and fibrotic uninvolved airways, but is disorganized in the honeycomb airways.</a:t>
            </a:r>
            <a:endParaRPr lang="en-GB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3227" y="2093269"/>
            <a:ext cx="1356519" cy="1017389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961" y="1030070"/>
            <a:ext cx="1356519" cy="1017389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5488" y="1030069"/>
            <a:ext cx="1356519" cy="1017389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961" y="2093269"/>
            <a:ext cx="1356519" cy="1017389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3452" y="4227417"/>
            <a:ext cx="1356519" cy="1017389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3227" y="4233219"/>
            <a:ext cx="1356519" cy="1017389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1466" y="4227418"/>
            <a:ext cx="1356519" cy="1017389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961" y="4236183"/>
            <a:ext cx="1356519" cy="1017389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3452" y="1018086"/>
            <a:ext cx="1356519" cy="1017389"/>
          </a:xfrm>
          <a:prstGeom prst="rect">
            <a:avLst/>
          </a:prstGeom>
        </p:spPr>
      </p:pic>
      <p:pic>
        <p:nvPicPr>
          <p:cNvPr id="53" name="Picture 52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3227" y="3168896"/>
            <a:ext cx="1356519" cy="1017389"/>
          </a:xfrm>
          <a:prstGeom prst="rect">
            <a:avLst/>
          </a:prstGeom>
        </p:spPr>
      </p:pic>
      <p:pic>
        <p:nvPicPr>
          <p:cNvPr id="59" name="Picture 5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3453" y="3165930"/>
            <a:ext cx="1356519" cy="1017389"/>
          </a:xfrm>
          <a:prstGeom prst="rect">
            <a:avLst/>
          </a:prstGeom>
        </p:spPr>
      </p:pic>
      <p:pic>
        <p:nvPicPr>
          <p:cNvPr id="60" name="Picture 5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1467" y="1018086"/>
            <a:ext cx="1356519" cy="1017389"/>
          </a:xfrm>
          <a:prstGeom prst="rect">
            <a:avLst/>
          </a:prstGeom>
        </p:spPr>
      </p:pic>
      <p:pic>
        <p:nvPicPr>
          <p:cNvPr id="61" name="Picture 60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962" y="3165931"/>
            <a:ext cx="1356519" cy="1017389"/>
          </a:xfrm>
          <a:prstGeom prst="rect">
            <a:avLst/>
          </a:prstGeom>
        </p:spPr>
      </p:pic>
      <p:pic>
        <p:nvPicPr>
          <p:cNvPr id="62" name="Picture 61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1467" y="3170519"/>
            <a:ext cx="1356519" cy="1017389"/>
          </a:xfrm>
          <a:prstGeom prst="rect">
            <a:avLst/>
          </a:prstGeom>
        </p:spPr>
      </p:pic>
      <p:pic>
        <p:nvPicPr>
          <p:cNvPr id="65" name="Picture 64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3455" y="2093269"/>
            <a:ext cx="1356519" cy="1017389"/>
          </a:xfrm>
          <a:prstGeom prst="rect">
            <a:avLst/>
          </a:prstGeom>
        </p:spPr>
      </p:pic>
      <p:pic>
        <p:nvPicPr>
          <p:cNvPr id="66" name="Picture 65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1466" y="2088765"/>
            <a:ext cx="1356519" cy="1017389"/>
          </a:xfrm>
          <a:prstGeom prst="rect">
            <a:avLst/>
          </a:prstGeom>
        </p:spPr>
      </p:pic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336BB6A1-F169-01D1-4A55-719BA7AB7E22}"/>
              </a:ext>
            </a:extLst>
          </p:cNvPr>
          <p:cNvCxnSpPr>
            <a:cxnSpLocks/>
          </p:cNvCxnSpPr>
          <p:nvPr/>
        </p:nvCxnSpPr>
        <p:spPr>
          <a:xfrm>
            <a:off x="539215" y="1018088"/>
            <a:ext cx="0" cy="209351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6A795221-D5F8-67B8-EA03-5E1B67D2EB4B}"/>
              </a:ext>
            </a:extLst>
          </p:cNvPr>
          <p:cNvCxnSpPr>
            <a:cxnSpLocks/>
          </p:cNvCxnSpPr>
          <p:nvPr/>
        </p:nvCxnSpPr>
        <p:spPr>
          <a:xfrm>
            <a:off x="545934" y="3165930"/>
            <a:ext cx="1" cy="208910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:a16="http://schemas.microsoft.com/office/drawing/2014/main" id="{2BD8DD2D-9DD2-3FEE-EC7A-EBA0A10D801B}"/>
              </a:ext>
            </a:extLst>
          </p:cNvPr>
          <p:cNvSpPr txBox="1"/>
          <p:nvPr/>
        </p:nvSpPr>
        <p:spPr>
          <a:xfrm rot="16200000">
            <a:off x="1405970" y="3029869"/>
            <a:ext cx="4226035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ibrotic  Honeycomb  Airway</a:t>
            </a:r>
          </a:p>
        </p:txBody>
      </p: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8B3BA8AA-D13C-482B-473B-24CD6E9FEC52}"/>
              </a:ext>
            </a:extLst>
          </p:cNvPr>
          <p:cNvCxnSpPr>
            <a:cxnSpLocks/>
          </p:cNvCxnSpPr>
          <p:nvPr/>
        </p:nvCxnSpPr>
        <p:spPr>
          <a:xfrm>
            <a:off x="3616568" y="1024573"/>
            <a:ext cx="0" cy="422603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7" name="TextBox 106">
            <a:extLst>
              <a:ext uri="{FF2B5EF4-FFF2-40B4-BE49-F238E27FC236}">
                <a16:creationId xmlns:a16="http://schemas.microsoft.com/office/drawing/2014/main" id="{462702D4-524E-33DA-1496-CDE47417AF5E}"/>
              </a:ext>
            </a:extLst>
          </p:cNvPr>
          <p:cNvSpPr txBox="1"/>
          <p:nvPr/>
        </p:nvSpPr>
        <p:spPr>
          <a:xfrm>
            <a:off x="3340753" y="1018088"/>
            <a:ext cx="3622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31598A1E-EFC6-4804-89FC-01A1460B9B34}"/>
              </a:ext>
            </a:extLst>
          </p:cNvPr>
          <p:cNvCxnSpPr>
            <a:cxnSpLocks/>
          </p:cNvCxnSpPr>
          <p:nvPr/>
        </p:nvCxnSpPr>
        <p:spPr>
          <a:xfrm>
            <a:off x="1679777" y="2001649"/>
            <a:ext cx="19854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31598A1E-EFC6-4804-89FC-01A1460B9B34}"/>
              </a:ext>
            </a:extLst>
          </p:cNvPr>
          <p:cNvCxnSpPr>
            <a:cxnSpLocks/>
          </p:cNvCxnSpPr>
          <p:nvPr/>
        </p:nvCxnSpPr>
        <p:spPr>
          <a:xfrm>
            <a:off x="3067268" y="2005448"/>
            <a:ext cx="19854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31598A1E-EFC6-4804-89FC-01A1460B9B34}"/>
              </a:ext>
            </a:extLst>
          </p:cNvPr>
          <p:cNvCxnSpPr>
            <a:cxnSpLocks/>
          </p:cNvCxnSpPr>
          <p:nvPr/>
        </p:nvCxnSpPr>
        <p:spPr>
          <a:xfrm>
            <a:off x="4757184" y="1992447"/>
            <a:ext cx="19854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31598A1E-EFC6-4804-89FC-01A1460B9B34}"/>
              </a:ext>
            </a:extLst>
          </p:cNvPr>
          <p:cNvCxnSpPr>
            <a:cxnSpLocks/>
          </p:cNvCxnSpPr>
          <p:nvPr/>
        </p:nvCxnSpPr>
        <p:spPr>
          <a:xfrm>
            <a:off x="6149009" y="1996246"/>
            <a:ext cx="19854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id="{38CA6A13-2B2B-424F-D802-BFBC5D8A7882}"/>
              </a:ext>
            </a:extLst>
          </p:cNvPr>
          <p:cNvSpPr txBox="1"/>
          <p:nvPr/>
        </p:nvSpPr>
        <p:spPr>
          <a:xfrm rot="16200000">
            <a:off x="-599961" y="1957126"/>
            <a:ext cx="2093519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on-fibrotic  Airway</a:t>
            </a:r>
          </a:p>
        </p:txBody>
      </p: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336BB6A1-F169-01D1-4A55-719BA7AB7E22}"/>
              </a:ext>
            </a:extLst>
          </p:cNvPr>
          <p:cNvCxnSpPr>
            <a:cxnSpLocks/>
          </p:cNvCxnSpPr>
          <p:nvPr/>
        </p:nvCxnSpPr>
        <p:spPr>
          <a:xfrm>
            <a:off x="539215" y="1018088"/>
            <a:ext cx="0" cy="209351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4" name="TextBox 113">
            <a:extLst>
              <a:ext uri="{FF2B5EF4-FFF2-40B4-BE49-F238E27FC236}">
                <a16:creationId xmlns:a16="http://schemas.microsoft.com/office/drawing/2014/main" id="{E05DAB4D-0D7A-7BFA-B416-43CA8FC1ABBB}"/>
              </a:ext>
            </a:extLst>
          </p:cNvPr>
          <p:cNvSpPr txBox="1"/>
          <p:nvPr/>
        </p:nvSpPr>
        <p:spPr>
          <a:xfrm rot="16200000">
            <a:off x="-591032" y="4102758"/>
            <a:ext cx="20891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ibrotic  Uninvolved  Airway</a:t>
            </a:r>
          </a:p>
        </p:txBody>
      </p: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6A795221-D5F8-67B8-EA03-5E1B67D2EB4B}"/>
              </a:ext>
            </a:extLst>
          </p:cNvPr>
          <p:cNvCxnSpPr>
            <a:cxnSpLocks/>
          </p:cNvCxnSpPr>
          <p:nvPr/>
        </p:nvCxnSpPr>
        <p:spPr>
          <a:xfrm>
            <a:off x="545934" y="3165930"/>
            <a:ext cx="1" cy="208910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7" name="TextBox 116">
            <a:extLst>
              <a:ext uri="{FF2B5EF4-FFF2-40B4-BE49-F238E27FC236}">
                <a16:creationId xmlns:a16="http://schemas.microsoft.com/office/drawing/2014/main" id="{7FA47D0C-D799-D4D3-2576-638718C60C98}"/>
              </a:ext>
            </a:extLst>
          </p:cNvPr>
          <p:cNvSpPr txBox="1"/>
          <p:nvPr/>
        </p:nvSpPr>
        <p:spPr>
          <a:xfrm>
            <a:off x="257457" y="3161507"/>
            <a:ext cx="3622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DD6AA240-344C-0AD9-FDB9-886D8E46C973}"/>
              </a:ext>
            </a:extLst>
          </p:cNvPr>
          <p:cNvSpPr txBox="1"/>
          <p:nvPr/>
        </p:nvSpPr>
        <p:spPr>
          <a:xfrm>
            <a:off x="1949379" y="802642"/>
            <a:ext cx="1356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Elas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D6AA240-344C-0AD9-FDB9-886D8E46C973}"/>
              </a:ext>
            </a:extLst>
          </p:cNvPr>
          <p:cNvSpPr txBox="1"/>
          <p:nvPr/>
        </p:nvSpPr>
        <p:spPr>
          <a:xfrm>
            <a:off x="3641466" y="804854"/>
            <a:ext cx="1356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Pentachrome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D6AA240-344C-0AD9-FDB9-886D8E46C973}"/>
              </a:ext>
            </a:extLst>
          </p:cNvPr>
          <p:cNvSpPr txBox="1"/>
          <p:nvPr/>
        </p:nvSpPr>
        <p:spPr>
          <a:xfrm>
            <a:off x="5022884" y="800433"/>
            <a:ext cx="13565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Elas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87600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60878" y="382291"/>
            <a:ext cx="4452505" cy="36933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65451" y="7113787"/>
            <a:ext cx="607236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: The mucus in mucinous adenocarcinoma (MA).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A specimen was serially sectioned at 5 microns and stained with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lcian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blue/periodic acid Schiff’s (AB/PAS) stain or Hemetoxylin &amp; Eosin (H&amp;E). Mucus was laser microdissected for mass spectrometry analysis. Scale bar represented 100 microns.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A list showing the most abundant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secretome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-associated proteins found in the mucus of MA (n = 6 patients).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Dotplot visualization of the MA mucus using Reactome pathway enrichment.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5810" y="1283715"/>
            <a:ext cx="1260850" cy="94055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2769" y="1283715"/>
            <a:ext cx="1260850" cy="940558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418" t="28231" r="22817" b="18874"/>
          <a:stretch/>
        </p:blipFill>
        <p:spPr>
          <a:xfrm>
            <a:off x="631593" y="1283715"/>
            <a:ext cx="1260850" cy="940558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19" t="31142" r="20117" b="11393"/>
          <a:stretch/>
        </p:blipFill>
        <p:spPr>
          <a:xfrm>
            <a:off x="1948552" y="1283715"/>
            <a:ext cx="1260850" cy="940558"/>
          </a:xfrm>
          <a:prstGeom prst="rect">
            <a:avLst/>
          </a:prstGeom>
        </p:spPr>
      </p:pic>
      <p:sp>
        <p:nvSpPr>
          <p:cNvPr id="12" name="Freeform 11"/>
          <p:cNvSpPr/>
          <p:nvPr/>
        </p:nvSpPr>
        <p:spPr>
          <a:xfrm>
            <a:off x="3501632" y="1699715"/>
            <a:ext cx="419124" cy="382175"/>
          </a:xfrm>
          <a:custGeom>
            <a:avLst/>
            <a:gdLst>
              <a:gd name="connsiteX0" fmla="*/ 236220 w 632460"/>
              <a:gd name="connsiteY0" fmla="*/ 22860 h 556260"/>
              <a:gd name="connsiteX1" fmla="*/ 182880 w 632460"/>
              <a:gd name="connsiteY1" fmla="*/ 19050 h 556260"/>
              <a:gd name="connsiteX2" fmla="*/ 121920 w 632460"/>
              <a:gd name="connsiteY2" fmla="*/ 0 h 556260"/>
              <a:gd name="connsiteX3" fmla="*/ 72390 w 632460"/>
              <a:gd name="connsiteY3" fmla="*/ 0 h 556260"/>
              <a:gd name="connsiteX4" fmla="*/ 11430 w 632460"/>
              <a:gd name="connsiteY4" fmla="*/ 11430 h 556260"/>
              <a:gd name="connsiteX5" fmla="*/ 0 w 632460"/>
              <a:gd name="connsiteY5" fmla="*/ 41910 h 556260"/>
              <a:gd name="connsiteX6" fmla="*/ 30480 w 632460"/>
              <a:gd name="connsiteY6" fmla="*/ 80010 h 556260"/>
              <a:gd name="connsiteX7" fmla="*/ 53340 w 632460"/>
              <a:gd name="connsiteY7" fmla="*/ 129540 h 556260"/>
              <a:gd name="connsiteX8" fmla="*/ 53340 w 632460"/>
              <a:gd name="connsiteY8" fmla="*/ 129540 h 556260"/>
              <a:gd name="connsiteX9" fmla="*/ 49530 w 632460"/>
              <a:gd name="connsiteY9" fmla="*/ 182880 h 556260"/>
              <a:gd name="connsiteX10" fmla="*/ 34290 w 632460"/>
              <a:gd name="connsiteY10" fmla="*/ 220980 h 556260"/>
              <a:gd name="connsiteX11" fmla="*/ 34290 w 632460"/>
              <a:gd name="connsiteY11" fmla="*/ 262890 h 556260"/>
              <a:gd name="connsiteX12" fmla="*/ 34290 w 632460"/>
              <a:gd name="connsiteY12" fmla="*/ 289560 h 556260"/>
              <a:gd name="connsiteX13" fmla="*/ 83820 w 632460"/>
              <a:gd name="connsiteY13" fmla="*/ 289560 h 556260"/>
              <a:gd name="connsiteX14" fmla="*/ 140970 w 632460"/>
              <a:gd name="connsiteY14" fmla="*/ 289560 h 556260"/>
              <a:gd name="connsiteX15" fmla="*/ 198120 w 632460"/>
              <a:gd name="connsiteY15" fmla="*/ 300990 h 556260"/>
              <a:gd name="connsiteX16" fmla="*/ 240030 w 632460"/>
              <a:gd name="connsiteY16" fmla="*/ 335280 h 556260"/>
              <a:gd name="connsiteX17" fmla="*/ 293370 w 632460"/>
              <a:gd name="connsiteY17" fmla="*/ 381000 h 556260"/>
              <a:gd name="connsiteX18" fmla="*/ 342900 w 632460"/>
              <a:gd name="connsiteY18" fmla="*/ 441960 h 556260"/>
              <a:gd name="connsiteX19" fmla="*/ 381000 w 632460"/>
              <a:gd name="connsiteY19" fmla="*/ 464820 h 556260"/>
              <a:gd name="connsiteX20" fmla="*/ 457200 w 632460"/>
              <a:gd name="connsiteY20" fmla="*/ 464820 h 556260"/>
              <a:gd name="connsiteX21" fmla="*/ 502920 w 632460"/>
              <a:gd name="connsiteY21" fmla="*/ 480060 h 556260"/>
              <a:gd name="connsiteX22" fmla="*/ 544830 w 632460"/>
              <a:gd name="connsiteY22" fmla="*/ 502920 h 556260"/>
              <a:gd name="connsiteX23" fmla="*/ 575310 w 632460"/>
              <a:gd name="connsiteY23" fmla="*/ 544830 h 556260"/>
              <a:gd name="connsiteX24" fmla="*/ 605790 w 632460"/>
              <a:gd name="connsiteY24" fmla="*/ 556260 h 556260"/>
              <a:gd name="connsiteX25" fmla="*/ 624840 w 632460"/>
              <a:gd name="connsiteY25" fmla="*/ 537210 h 556260"/>
              <a:gd name="connsiteX26" fmla="*/ 632460 w 632460"/>
              <a:gd name="connsiteY26" fmla="*/ 476250 h 556260"/>
              <a:gd name="connsiteX27" fmla="*/ 632460 w 632460"/>
              <a:gd name="connsiteY27" fmla="*/ 419100 h 556260"/>
              <a:gd name="connsiteX28" fmla="*/ 632460 w 632460"/>
              <a:gd name="connsiteY28" fmla="*/ 396240 h 556260"/>
              <a:gd name="connsiteX29" fmla="*/ 609600 w 632460"/>
              <a:gd name="connsiteY29" fmla="*/ 361950 h 556260"/>
              <a:gd name="connsiteX30" fmla="*/ 586740 w 632460"/>
              <a:gd name="connsiteY30" fmla="*/ 331470 h 556260"/>
              <a:gd name="connsiteX31" fmla="*/ 563880 w 632460"/>
              <a:gd name="connsiteY31" fmla="*/ 308610 h 556260"/>
              <a:gd name="connsiteX32" fmla="*/ 537210 w 632460"/>
              <a:gd name="connsiteY32" fmla="*/ 293370 h 556260"/>
              <a:gd name="connsiteX33" fmla="*/ 510540 w 632460"/>
              <a:gd name="connsiteY33" fmla="*/ 278130 h 556260"/>
              <a:gd name="connsiteX34" fmla="*/ 483870 w 632460"/>
              <a:gd name="connsiteY34" fmla="*/ 243840 h 556260"/>
              <a:gd name="connsiteX35" fmla="*/ 445770 w 632460"/>
              <a:gd name="connsiteY35" fmla="*/ 224790 h 556260"/>
              <a:gd name="connsiteX36" fmla="*/ 415290 w 632460"/>
              <a:gd name="connsiteY36" fmla="*/ 213360 h 556260"/>
              <a:gd name="connsiteX37" fmla="*/ 369570 w 632460"/>
              <a:gd name="connsiteY37" fmla="*/ 198120 h 556260"/>
              <a:gd name="connsiteX38" fmla="*/ 339090 w 632460"/>
              <a:gd name="connsiteY38" fmla="*/ 186690 h 556260"/>
              <a:gd name="connsiteX39" fmla="*/ 308610 w 632460"/>
              <a:gd name="connsiteY39" fmla="*/ 121920 h 556260"/>
              <a:gd name="connsiteX40" fmla="*/ 236220 w 632460"/>
              <a:gd name="connsiteY40" fmla="*/ 22860 h 5562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</a:cxnLst>
            <a:rect l="l" t="t" r="r" b="b"/>
            <a:pathLst>
              <a:path w="632460" h="556260">
                <a:moveTo>
                  <a:pt x="236220" y="22860"/>
                </a:moveTo>
                <a:lnTo>
                  <a:pt x="182880" y="19050"/>
                </a:lnTo>
                <a:lnTo>
                  <a:pt x="121920" y="0"/>
                </a:lnTo>
                <a:lnTo>
                  <a:pt x="72390" y="0"/>
                </a:lnTo>
                <a:lnTo>
                  <a:pt x="11430" y="11430"/>
                </a:lnTo>
                <a:lnTo>
                  <a:pt x="0" y="41910"/>
                </a:lnTo>
                <a:lnTo>
                  <a:pt x="30480" y="80010"/>
                </a:lnTo>
                <a:lnTo>
                  <a:pt x="53340" y="129540"/>
                </a:lnTo>
                <a:lnTo>
                  <a:pt x="53340" y="129540"/>
                </a:lnTo>
                <a:lnTo>
                  <a:pt x="49530" y="182880"/>
                </a:lnTo>
                <a:lnTo>
                  <a:pt x="34290" y="220980"/>
                </a:lnTo>
                <a:lnTo>
                  <a:pt x="34290" y="262890"/>
                </a:lnTo>
                <a:lnTo>
                  <a:pt x="34290" y="289560"/>
                </a:lnTo>
                <a:lnTo>
                  <a:pt x="83820" y="289560"/>
                </a:lnTo>
                <a:lnTo>
                  <a:pt x="140970" y="289560"/>
                </a:lnTo>
                <a:lnTo>
                  <a:pt x="198120" y="300990"/>
                </a:lnTo>
                <a:lnTo>
                  <a:pt x="240030" y="335280"/>
                </a:lnTo>
                <a:lnTo>
                  <a:pt x="293370" y="381000"/>
                </a:lnTo>
                <a:lnTo>
                  <a:pt x="342900" y="441960"/>
                </a:lnTo>
                <a:lnTo>
                  <a:pt x="381000" y="464820"/>
                </a:lnTo>
                <a:lnTo>
                  <a:pt x="457200" y="464820"/>
                </a:lnTo>
                <a:lnTo>
                  <a:pt x="502920" y="480060"/>
                </a:lnTo>
                <a:lnTo>
                  <a:pt x="544830" y="502920"/>
                </a:lnTo>
                <a:lnTo>
                  <a:pt x="575310" y="544830"/>
                </a:lnTo>
                <a:lnTo>
                  <a:pt x="605790" y="556260"/>
                </a:lnTo>
                <a:lnTo>
                  <a:pt x="624840" y="537210"/>
                </a:lnTo>
                <a:lnTo>
                  <a:pt x="632460" y="476250"/>
                </a:lnTo>
                <a:lnTo>
                  <a:pt x="632460" y="419100"/>
                </a:lnTo>
                <a:lnTo>
                  <a:pt x="632460" y="396240"/>
                </a:lnTo>
                <a:lnTo>
                  <a:pt x="609600" y="361950"/>
                </a:lnTo>
                <a:lnTo>
                  <a:pt x="586740" y="331470"/>
                </a:lnTo>
                <a:lnTo>
                  <a:pt x="563880" y="308610"/>
                </a:lnTo>
                <a:lnTo>
                  <a:pt x="537210" y="293370"/>
                </a:lnTo>
                <a:lnTo>
                  <a:pt x="510540" y="278130"/>
                </a:lnTo>
                <a:lnTo>
                  <a:pt x="483870" y="243840"/>
                </a:lnTo>
                <a:lnTo>
                  <a:pt x="445770" y="224790"/>
                </a:lnTo>
                <a:lnTo>
                  <a:pt x="415290" y="213360"/>
                </a:lnTo>
                <a:lnTo>
                  <a:pt x="369570" y="198120"/>
                </a:lnTo>
                <a:lnTo>
                  <a:pt x="339090" y="186690"/>
                </a:lnTo>
                <a:lnTo>
                  <a:pt x="308610" y="121920"/>
                </a:lnTo>
                <a:lnTo>
                  <a:pt x="236220" y="22860"/>
                </a:lnTo>
                <a:close/>
              </a:path>
            </a:pathLst>
          </a:custGeom>
          <a:noFill/>
          <a:ln w="1270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Freeform 12"/>
          <p:cNvSpPr/>
          <p:nvPr/>
        </p:nvSpPr>
        <p:spPr>
          <a:xfrm>
            <a:off x="3807373" y="1633535"/>
            <a:ext cx="174214" cy="196322"/>
          </a:xfrm>
          <a:custGeom>
            <a:avLst/>
            <a:gdLst>
              <a:gd name="connsiteX0" fmla="*/ 262890 w 262890"/>
              <a:gd name="connsiteY0" fmla="*/ 57150 h 285750"/>
              <a:gd name="connsiteX1" fmla="*/ 262890 w 262890"/>
              <a:gd name="connsiteY1" fmla="*/ 57150 h 285750"/>
              <a:gd name="connsiteX2" fmla="*/ 175260 w 262890"/>
              <a:gd name="connsiteY2" fmla="*/ 53340 h 285750"/>
              <a:gd name="connsiteX3" fmla="*/ 129540 w 262890"/>
              <a:gd name="connsiteY3" fmla="*/ 30480 h 285750"/>
              <a:gd name="connsiteX4" fmla="*/ 118110 w 262890"/>
              <a:gd name="connsiteY4" fmla="*/ 19050 h 285750"/>
              <a:gd name="connsiteX5" fmla="*/ 95250 w 262890"/>
              <a:gd name="connsiteY5" fmla="*/ 11430 h 285750"/>
              <a:gd name="connsiteX6" fmla="*/ 72390 w 262890"/>
              <a:gd name="connsiteY6" fmla="*/ 0 h 285750"/>
              <a:gd name="connsiteX7" fmla="*/ 41910 w 262890"/>
              <a:gd name="connsiteY7" fmla="*/ 11430 h 285750"/>
              <a:gd name="connsiteX8" fmla="*/ 38100 w 262890"/>
              <a:gd name="connsiteY8" fmla="*/ 22860 h 285750"/>
              <a:gd name="connsiteX9" fmla="*/ 34290 w 262890"/>
              <a:gd name="connsiteY9" fmla="*/ 95250 h 285750"/>
              <a:gd name="connsiteX10" fmla="*/ 26670 w 262890"/>
              <a:gd name="connsiteY10" fmla="*/ 118110 h 285750"/>
              <a:gd name="connsiteX11" fmla="*/ 15240 w 262890"/>
              <a:gd name="connsiteY11" fmla="*/ 152400 h 285750"/>
              <a:gd name="connsiteX12" fmla="*/ 11430 w 262890"/>
              <a:gd name="connsiteY12" fmla="*/ 163830 h 285750"/>
              <a:gd name="connsiteX13" fmla="*/ 0 w 262890"/>
              <a:gd name="connsiteY13" fmla="*/ 186690 h 285750"/>
              <a:gd name="connsiteX14" fmla="*/ 19050 w 262890"/>
              <a:gd name="connsiteY14" fmla="*/ 259080 h 285750"/>
              <a:gd name="connsiteX15" fmla="*/ 30480 w 262890"/>
              <a:gd name="connsiteY15" fmla="*/ 262890 h 285750"/>
              <a:gd name="connsiteX16" fmla="*/ 57150 w 262890"/>
              <a:gd name="connsiteY16" fmla="*/ 281940 h 285750"/>
              <a:gd name="connsiteX17" fmla="*/ 68580 w 262890"/>
              <a:gd name="connsiteY17" fmla="*/ 285750 h 285750"/>
              <a:gd name="connsiteX18" fmla="*/ 87630 w 262890"/>
              <a:gd name="connsiteY18" fmla="*/ 281940 h 285750"/>
              <a:gd name="connsiteX19" fmla="*/ 110490 w 262890"/>
              <a:gd name="connsiteY19" fmla="*/ 266700 h 285750"/>
              <a:gd name="connsiteX20" fmla="*/ 133350 w 262890"/>
              <a:gd name="connsiteY20" fmla="*/ 255270 h 285750"/>
              <a:gd name="connsiteX21" fmla="*/ 156210 w 262890"/>
              <a:gd name="connsiteY21" fmla="*/ 247650 h 285750"/>
              <a:gd name="connsiteX22" fmla="*/ 167640 w 262890"/>
              <a:gd name="connsiteY22" fmla="*/ 240030 h 285750"/>
              <a:gd name="connsiteX23" fmla="*/ 190500 w 262890"/>
              <a:gd name="connsiteY23" fmla="*/ 232410 h 285750"/>
              <a:gd name="connsiteX24" fmla="*/ 201930 w 262890"/>
              <a:gd name="connsiteY24" fmla="*/ 228600 h 285750"/>
              <a:gd name="connsiteX25" fmla="*/ 213360 w 262890"/>
              <a:gd name="connsiteY25" fmla="*/ 220980 h 285750"/>
              <a:gd name="connsiteX26" fmla="*/ 228600 w 262890"/>
              <a:gd name="connsiteY26" fmla="*/ 198120 h 285750"/>
              <a:gd name="connsiteX27" fmla="*/ 236220 w 262890"/>
              <a:gd name="connsiteY27" fmla="*/ 175260 h 285750"/>
              <a:gd name="connsiteX28" fmla="*/ 240030 w 262890"/>
              <a:gd name="connsiteY28" fmla="*/ 160020 h 285750"/>
              <a:gd name="connsiteX29" fmla="*/ 251460 w 262890"/>
              <a:gd name="connsiteY29" fmla="*/ 121920 h 285750"/>
              <a:gd name="connsiteX30" fmla="*/ 262890 w 262890"/>
              <a:gd name="connsiteY30" fmla="*/ 57150 h 2857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</a:cxnLst>
            <a:rect l="l" t="t" r="r" b="b"/>
            <a:pathLst>
              <a:path w="262890" h="285750">
                <a:moveTo>
                  <a:pt x="262890" y="57150"/>
                </a:moveTo>
                <a:lnTo>
                  <a:pt x="262890" y="57150"/>
                </a:lnTo>
                <a:cubicBezTo>
                  <a:pt x="233680" y="55880"/>
                  <a:pt x="204342" y="56349"/>
                  <a:pt x="175260" y="53340"/>
                </a:cubicBezTo>
                <a:cubicBezTo>
                  <a:pt x="161435" y="51910"/>
                  <a:pt x="138876" y="39816"/>
                  <a:pt x="129540" y="30480"/>
                </a:cubicBezTo>
                <a:cubicBezTo>
                  <a:pt x="125730" y="26670"/>
                  <a:pt x="122820" y="21667"/>
                  <a:pt x="118110" y="19050"/>
                </a:cubicBezTo>
                <a:cubicBezTo>
                  <a:pt x="111089" y="15149"/>
                  <a:pt x="101933" y="15885"/>
                  <a:pt x="95250" y="11430"/>
                </a:cubicBezTo>
                <a:cubicBezTo>
                  <a:pt x="80478" y="1582"/>
                  <a:pt x="88164" y="5258"/>
                  <a:pt x="72390" y="0"/>
                </a:cubicBezTo>
                <a:cubicBezTo>
                  <a:pt x="62063" y="2065"/>
                  <a:pt x="49385" y="2087"/>
                  <a:pt x="41910" y="11430"/>
                </a:cubicBezTo>
                <a:cubicBezTo>
                  <a:pt x="39401" y="14566"/>
                  <a:pt x="39370" y="19050"/>
                  <a:pt x="38100" y="22860"/>
                </a:cubicBezTo>
                <a:cubicBezTo>
                  <a:pt x="36830" y="46990"/>
                  <a:pt x="37169" y="71259"/>
                  <a:pt x="34290" y="95250"/>
                </a:cubicBezTo>
                <a:cubicBezTo>
                  <a:pt x="33333" y="103225"/>
                  <a:pt x="29210" y="110490"/>
                  <a:pt x="26670" y="118110"/>
                </a:cubicBezTo>
                <a:lnTo>
                  <a:pt x="15240" y="152400"/>
                </a:lnTo>
                <a:cubicBezTo>
                  <a:pt x="13970" y="156210"/>
                  <a:pt x="13658" y="160488"/>
                  <a:pt x="11430" y="163830"/>
                </a:cubicBezTo>
                <a:cubicBezTo>
                  <a:pt x="1582" y="178602"/>
                  <a:pt x="5258" y="170916"/>
                  <a:pt x="0" y="186690"/>
                </a:cubicBezTo>
                <a:cubicBezTo>
                  <a:pt x="445" y="192472"/>
                  <a:pt x="-3125" y="251688"/>
                  <a:pt x="19050" y="259080"/>
                </a:cubicBezTo>
                <a:lnTo>
                  <a:pt x="30480" y="262890"/>
                </a:lnTo>
                <a:cubicBezTo>
                  <a:pt x="36830" y="281940"/>
                  <a:pt x="30480" y="273050"/>
                  <a:pt x="57150" y="281940"/>
                </a:cubicBezTo>
                <a:lnTo>
                  <a:pt x="68580" y="285750"/>
                </a:lnTo>
                <a:cubicBezTo>
                  <a:pt x="74930" y="284480"/>
                  <a:pt x="81735" y="284620"/>
                  <a:pt x="87630" y="281940"/>
                </a:cubicBezTo>
                <a:cubicBezTo>
                  <a:pt x="95967" y="278150"/>
                  <a:pt x="101802" y="269596"/>
                  <a:pt x="110490" y="266700"/>
                </a:cubicBezTo>
                <a:cubicBezTo>
                  <a:pt x="152175" y="252805"/>
                  <a:pt x="89035" y="274965"/>
                  <a:pt x="133350" y="255270"/>
                </a:cubicBezTo>
                <a:cubicBezTo>
                  <a:pt x="140690" y="252008"/>
                  <a:pt x="149527" y="252105"/>
                  <a:pt x="156210" y="247650"/>
                </a:cubicBezTo>
                <a:cubicBezTo>
                  <a:pt x="160020" y="245110"/>
                  <a:pt x="163456" y="241890"/>
                  <a:pt x="167640" y="240030"/>
                </a:cubicBezTo>
                <a:cubicBezTo>
                  <a:pt x="174980" y="236768"/>
                  <a:pt x="182880" y="234950"/>
                  <a:pt x="190500" y="232410"/>
                </a:cubicBezTo>
                <a:cubicBezTo>
                  <a:pt x="194310" y="231140"/>
                  <a:pt x="198588" y="230828"/>
                  <a:pt x="201930" y="228600"/>
                </a:cubicBezTo>
                <a:lnTo>
                  <a:pt x="213360" y="220980"/>
                </a:lnTo>
                <a:cubicBezTo>
                  <a:pt x="218440" y="213360"/>
                  <a:pt x="225704" y="206808"/>
                  <a:pt x="228600" y="198120"/>
                </a:cubicBezTo>
                <a:cubicBezTo>
                  <a:pt x="231140" y="190500"/>
                  <a:pt x="234272" y="183052"/>
                  <a:pt x="236220" y="175260"/>
                </a:cubicBezTo>
                <a:cubicBezTo>
                  <a:pt x="237490" y="170180"/>
                  <a:pt x="238525" y="165036"/>
                  <a:pt x="240030" y="160020"/>
                </a:cubicBezTo>
                <a:cubicBezTo>
                  <a:pt x="241820" y="154052"/>
                  <a:pt x="250582" y="130702"/>
                  <a:pt x="251460" y="121920"/>
                </a:cubicBezTo>
                <a:cubicBezTo>
                  <a:pt x="252218" y="114338"/>
                  <a:pt x="260985" y="67945"/>
                  <a:pt x="262890" y="57150"/>
                </a:cubicBezTo>
                <a:close/>
              </a:path>
            </a:pathLst>
          </a:custGeom>
          <a:noFill/>
          <a:ln w="1270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Freeform 13"/>
          <p:cNvSpPr/>
          <p:nvPr/>
        </p:nvSpPr>
        <p:spPr>
          <a:xfrm>
            <a:off x="3975818" y="1808566"/>
            <a:ext cx="207037" cy="204175"/>
          </a:xfrm>
          <a:custGeom>
            <a:avLst/>
            <a:gdLst>
              <a:gd name="connsiteX0" fmla="*/ 304800 w 312420"/>
              <a:gd name="connsiteY0" fmla="*/ 80010 h 297180"/>
              <a:gd name="connsiteX1" fmla="*/ 304800 w 312420"/>
              <a:gd name="connsiteY1" fmla="*/ 80010 h 297180"/>
              <a:gd name="connsiteX2" fmla="*/ 278130 w 312420"/>
              <a:gd name="connsiteY2" fmla="*/ 60960 h 297180"/>
              <a:gd name="connsiteX3" fmla="*/ 255270 w 312420"/>
              <a:gd name="connsiteY3" fmla="*/ 53340 h 297180"/>
              <a:gd name="connsiteX4" fmla="*/ 220980 w 312420"/>
              <a:gd name="connsiteY4" fmla="*/ 41910 h 297180"/>
              <a:gd name="connsiteX5" fmla="*/ 209550 w 312420"/>
              <a:gd name="connsiteY5" fmla="*/ 38100 h 297180"/>
              <a:gd name="connsiteX6" fmla="*/ 198120 w 312420"/>
              <a:gd name="connsiteY6" fmla="*/ 30480 h 297180"/>
              <a:gd name="connsiteX7" fmla="*/ 175260 w 312420"/>
              <a:gd name="connsiteY7" fmla="*/ 22860 h 297180"/>
              <a:gd name="connsiteX8" fmla="*/ 152400 w 312420"/>
              <a:gd name="connsiteY8" fmla="*/ 11430 h 297180"/>
              <a:gd name="connsiteX9" fmla="*/ 129540 w 312420"/>
              <a:gd name="connsiteY9" fmla="*/ 0 h 297180"/>
              <a:gd name="connsiteX10" fmla="*/ 95250 w 312420"/>
              <a:gd name="connsiteY10" fmla="*/ 7620 h 297180"/>
              <a:gd name="connsiteX11" fmla="*/ 76200 w 312420"/>
              <a:gd name="connsiteY11" fmla="*/ 22860 h 297180"/>
              <a:gd name="connsiteX12" fmla="*/ 57150 w 312420"/>
              <a:gd name="connsiteY12" fmla="*/ 38100 h 297180"/>
              <a:gd name="connsiteX13" fmla="*/ 49530 w 312420"/>
              <a:gd name="connsiteY13" fmla="*/ 49530 h 297180"/>
              <a:gd name="connsiteX14" fmla="*/ 38100 w 312420"/>
              <a:gd name="connsiteY14" fmla="*/ 57150 h 297180"/>
              <a:gd name="connsiteX15" fmla="*/ 11430 w 312420"/>
              <a:gd name="connsiteY15" fmla="*/ 76200 h 297180"/>
              <a:gd name="connsiteX16" fmla="*/ 0 w 312420"/>
              <a:gd name="connsiteY16" fmla="*/ 83820 h 297180"/>
              <a:gd name="connsiteX17" fmla="*/ 41910 w 312420"/>
              <a:gd name="connsiteY17" fmla="*/ 110490 h 297180"/>
              <a:gd name="connsiteX18" fmla="*/ 60960 w 312420"/>
              <a:gd name="connsiteY18" fmla="*/ 144780 h 297180"/>
              <a:gd name="connsiteX19" fmla="*/ 76200 w 312420"/>
              <a:gd name="connsiteY19" fmla="*/ 182880 h 297180"/>
              <a:gd name="connsiteX20" fmla="*/ 80010 w 312420"/>
              <a:gd name="connsiteY20" fmla="*/ 236220 h 297180"/>
              <a:gd name="connsiteX21" fmla="*/ 87630 w 312420"/>
              <a:gd name="connsiteY21" fmla="*/ 270510 h 297180"/>
              <a:gd name="connsiteX22" fmla="*/ 87630 w 312420"/>
              <a:gd name="connsiteY22" fmla="*/ 270510 h 297180"/>
              <a:gd name="connsiteX23" fmla="*/ 137160 w 312420"/>
              <a:gd name="connsiteY23" fmla="*/ 285750 h 297180"/>
              <a:gd name="connsiteX24" fmla="*/ 190500 w 312420"/>
              <a:gd name="connsiteY24" fmla="*/ 297180 h 297180"/>
              <a:gd name="connsiteX25" fmla="*/ 220980 w 312420"/>
              <a:gd name="connsiteY25" fmla="*/ 289560 h 297180"/>
              <a:gd name="connsiteX26" fmla="*/ 236220 w 312420"/>
              <a:gd name="connsiteY26" fmla="*/ 255270 h 297180"/>
              <a:gd name="connsiteX27" fmla="*/ 247650 w 312420"/>
              <a:gd name="connsiteY27" fmla="*/ 217170 h 297180"/>
              <a:gd name="connsiteX28" fmla="*/ 262890 w 312420"/>
              <a:gd name="connsiteY28" fmla="*/ 186690 h 297180"/>
              <a:gd name="connsiteX29" fmla="*/ 297180 w 312420"/>
              <a:gd name="connsiteY29" fmla="*/ 163830 h 297180"/>
              <a:gd name="connsiteX30" fmla="*/ 312420 w 312420"/>
              <a:gd name="connsiteY30" fmla="*/ 133350 h 297180"/>
              <a:gd name="connsiteX31" fmla="*/ 304800 w 312420"/>
              <a:gd name="connsiteY31" fmla="*/ 80010 h 2971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</a:cxnLst>
            <a:rect l="l" t="t" r="r" b="b"/>
            <a:pathLst>
              <a:path w="312420" h="297180">
                <a:moveTo>
                  <a:pt x="304800" y="80010"/>
                </a:moveTo>
                <a:lnTo>
                  <a:pt x="304800" y="80010"/>
                </a:lnTo>
                <a:cubicBezTo>
                  <a:pt x="295910" y="73660"/>
                  <a:pt x="287749" y="66140"/>
                  <a:pt x="278130" y="60960"/>
                </a:cubicBezTo>
                <a:cubicBezTo>
                  <a:pt x="271058" y="57152"/>
                  <a:pt x="262890" y="55880"/>
                  <a:pt x="255270" y="53340"/>
                </a:cubicBezTo>
                <a:lnTo>
                  <a:pt x="220980" y="41910"/>
                </a:lnTo>
                <a:cubicBezTo>
                  <a:pt x="217170" y="40640"/>
                  <a:pt x="212892" y="40328"/>
                  <a:pt x="209550" y="38100"/>
                </a:cubicBezTo>
                <a:cubicBezTo>
                  <a:pt x="205740" y="35560"/>
                  <a:pt x="202304" y="32340"/>
                  <a:pt x="198120" y="30480"/>
                </a:cubicBezTo>
                <a:cubicBezTo>
                  <a:pt x="190780" y="27218"/>
                  <a:pt x="181943" y="27315"/>
                  <a:pt x="175260" y="22860"/>
                </a:cubicBezTo>
                <a:cubicBezTo>
                  <a:pt x="142503" y="1022"/>
                  <a:pt x="183948" y="27204"/>
                  <a:pt x="152400" y="11430"/>
                </a:cubicBezTo>
                <a:cubicBezTo>
                  <a:pt x="122857" y="-3342"/>
                  <a:pt x="158270" y="9577"/>
                  <a:pt x="129540" y="0"/>
                </a:cubicBezTo>
                <a:cubicBezTo>
                  <a:pt x="129306" y="39"/>
                  <a:pt x="100186" y="3671"/>
                  <a:pt x="95250" y="7620"/>
                </a:cubicBezTo>
                <a:cubicBezTo>
                  <a:pt x="70631" y="27315"/>
                  <a:pt x="104930" y="13283"/>
                  <a:pt x="76200" y="22860"/>
                </a:cubicBezTo>
                <a:cubicBezTo>
                  <a:pt x="54362" y="55617"/>
                  <a:pt x="83440" y="17068"/>
                  <a:pt x="57150" y="38100"/>
                </a:cubicBezTo>
                <a:cubicBezTo>
                  <a:pt x="53574" y="40961"/>
                  <a:pt x="52768" y="46292"/>
                  <a:pt x="49530" y="49530"/>
                </a:cubicBezTo>
                <a:cubicBezTo>
                  <a:pt x="46292" y="52768"/>
                  <a:pt x="41910" y="54610"/>
                  <a:pt x="38100" y="57150"/>
                </a:cubicBezTo>
                <a:cubicBezTo>
                  <a:pt x="29845" y="81915"/>
                  <a:pt x="41910" y="55880"/>
                  <a:pt x="11430" y="76200"/>
                </a:cubicBezTo>
                <a:lnTo>
                  <a:pt x="0" y="83820"/>
                </a:lnTo>
                <a:lnTo>
                  <a:pt x="41910" y="110490"/>
                </a:lnTo>
                <a:lnTo>
                  <a:pt x="60960" y="144780"/>
                </a:lnTo>
                <a:lnTo>
                  <a:pt x="76200" y="182880"/>
                </a:lnTo>
                <a:lnTo>
                  <a:pt x="80010" y="236220"/>
                </a:lnTo>
                <a:lnTo>
                  <a:pt x="87630" y="270510"/>
                </a:lnTo>
                <a:lnTo>
                  <a:pt x="87630" y="270510"/>
                </a:lnTo>
                <a:lnTo>
                  <a:pt x="137160" y="285750"/>
                </a:lnTo>
                <a:lnTo>
                  <a:pt x="190500" y="297180"/>
                </a:lnTo>
                <a:lnTo>
                  <a:pt x="220980" y="289560"/>
                </a:lnTo>
                <a:lnTo>
                  <a:pt x="236220" y="255270"/>
                </a:lnTo>
                <a:lnTo>
                  <a:pt x="247650" y="217170"/>
                </a:lnTo>
                <a:lnTo>
                  <a:pt x="262890" y="186690"/>
                </a:lnTo>
                <a:lnTo>
                  <a:pt x="297180" y="163830"/>
                </a:lnTo>
                <a:lnTo>
                  <a:pt x="312420" y="133350"/>
                </a:lnTo>
                <a:lnTo>
                  <a:pt x="304800" y="80010"/>
                </a:lnTo>
                <a:close/>
              </a:path>
            </a:pathLst>
          </a:custGeom>
          <a:noFill/>
          <a:ln w="1270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Freeform 14"/>
          <p:cNvSpPr/>
          <p:nvPr/>
        </p:nvSpPr>
        <p:spPr>
          <a:xfrm>
            <a:off x="4187524" y="1311344"/>
            <a:ext cx="335804" cy="227734"/>
          </a:xfrm>
          <a:custGeom>
            <a:avLst/>
            <a:gdLst>
              <a:gd name="connsiteX0" fmla="*/ 506730 w 506730"/>
              <a:gd name="connsiteY0" fmla="*/ 15240 h 331470"/>
              <a:gd name="connsiteX1" fmla="*/ 441960 w 506730"/>
              <a:gd name="connsiteY1" fmla="*/ 15240 h 331470"/>
              <a:gd name="connsiteX2" fmla="*/ 365760 w 506730"/>
              <a:gd name="connsiteY2" fmla="*/ 15240 h 331470"/>
              <a:gd name="connsiteX3" fmla="*/ 312420 w 506730"/>
              <a:gd name="connsiteY3" fmla="*/ 15240 h 331470"/>
              <a:gd name="connsiteX4" fmla="*/ 270510 w 506730"/>
              <a:gd name="connsiteY4" fmla="*/ 7620 h 331470"/>
              <a:gd name="connsiteX5" fmla="*/ 217170 w 506730"/>
              <a:gd name="connsiteY5" fmla="*/ 7620 h 331470"/>
              <a:gd name="connsiteX6" fmla="*/ 106680 w 506730"/>
              <a:gd name="connsiteY6" fmla="*/ 0 h 331470"/>
              <a:gd name="connsiteX7" fmla="*/ 76200 w 506730"/>
              <a:gd name="connsiteY7" fmla="*/ 0 h 331470"/>
              <a:gd name="connsiteX8" fmla="*/ 49530 w 506730"/>
              <a:gd name="connsiteY8" fmla="*/ 22860 h 331470"/>
              <a:gd name="connsiteX9" fmla="*/ 22860 w 506730"/>
              <a:gd name="connsiteY9" fmla="*/ 45720 h 331470"/>
              <a:gd name="connsiteX10" fmla="*/ 3810 w 506730"/>
              <a:gd name="connsiteY10" fmla="*/ 72390 h 331470"/>
              <a:gd name="connsiteX11" fmla="*/ 0 w 506730"/>
              <a:gd name="connsiteY11" fmla="*/ 99060 h 331470"/>
              <a:gd name="connsiteX12" fmla="*/ 0 w 506730"/>
              <a:gd name="connsiteY12" fmla="*/ 133350 h 331470"/>
              <a:gd name="connsiteX13" fmla="*/ 3810 w 506730"/>
              <a:gd name="connsiteY13" fmla="*/ 163830 h 331470"/>
              <a:gd name="connsiteX14" fmla="*/ 15240 w 506730"/>
              <a:gd name="connsiteY14" fmla="*/ 213360 h 331470"/>
              <a:gd name="connsiteX15" fmla="*/ 30480 w 506730"/>
              <a:gd name="connsiteY15" fmla="*/ 251460 h 331470"/>
              <a:gd name="connsiteX16" fmla="*/ 49530 w 506730"/>
              <a:gd name="connsiteY16" fmla="*/ 289560 h 331470"/>
              <a:gd name="connsiteX17" fmla="*/ 87630 w 506730"/>
              <a:gd name="connsiteY17" fmla="*/ 300990 h 331470"/>
              <a:gd name="connsiteX18" fmla="*/ 118110 w 506730"/>
              <a:gd name="connsiteY18" fmla="*/ 304800 h 331470"/>
              <a:gd name="connsiteX19" fmla="*/ 148590 w 506730"/>
              <a:gd name="connsiteY19" fmla="*/ 316230 h 331470"/>
              <a:gd name="connsiteX20" fmla="*/ 205740 w 506730"/>
              <a:gd name="connsiteY20" fmla="*/ 327660 h 331470"/>
              <a:gd name="connsiteX21" fmla="*/ 255270 w 506730"/>
              <a:gd name="connsiteY21" fmla="*/ 331470 h 331470"/>
              <a:gd name="connsiteX22" fmla="*/ 293370 w 506730"/>
              <a:gd name="connsiteY22" fmla="*/ 327660 h 331470"/>
              <a:gd name="connsiteX23" fmla="*/ 346710 w 506730"/>
              <a:gd name="connsiteY23" fmla="*/ 278130 h 331470"/>
              <a:gd name="connsiteX24" fmla="*/ 381000 w 506730"/>
              <a:gd name="connsiteY24" fmla="*/ 236220 h 331470"/>
              <a:gd name="connsiteX25" fmla="*/ 411480 w 506730"/>
              <a:gd name="connsiteY25" fmla="*/ 201930 h 331470"/>
              <a:gd name="connsiteX26" fmla="*/ 445770 w 506730"/>
              <a:gd name="connsiteY26" fmla="*/ 160020 h 331470"/>
              <a:gd name="connsiteX27" fmla="*/ 468630 w 506730"/>
              <a:gd name="connsiteY27" fmla="*/ 129540 h 331470"/>
              <a:gd name="connsiteX28" fmla="*/ 487680 w 506730"/>
              <a:gd name="connsiteY28" fmla="*/ 99060 h 331470"/>
              <a:gd name="connsiteX29" fmla="*/ 506730 w 506730"/>
              <a:gd name="connsiteY29" fmla="*/ 68580 h 331470"/>
              <a:gd name="connsiteX30" fmla="*/ 506730 w 506730"/>
              <a:gd name="connsiteY30" fmla="*/ 15240 h 3314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</a:cxnLst>
            <a:rect l="l" t="t" r="r" b="b"/>
            <a:pathLst>
              <a:path w="506730" h="331470">
                <a:moveTo>
                  <a:pt x="506730" y="15240"/>
                </a:moveTo>
                <a:lnTo>
                  <a:pt x="441960" y="15240"/>
                </a:lnTo>
                <a:lnTo>
                  <a:pt x="365760" y="15240"/>
                </a:lnTo>
                <a:lnTo>
                  <a:pt x="312420" y="15240"/>
                </a:lnTo>
                <a:lnTo>
                  <a:pt x="270510" y="7620"/>
                </a:lnTo>
                <a:lnTo>
                  <a:pt x="217170" y="7620"/>
                </a:lnTo>
                <a:lnTo>
                  <a:pt x="106680" y="0"/>
                </a:lnTo>
                <a:lnTo>
                  <a:pt x="76200" y="0"/>
                </a:lnTo>
                <a:lnTo>
                  <a:pt x="49530" y="22860"/>
                </a:lnTo>
                <a:lnTo>
                  <a:pt x="22860" y="45720"/>
                </a:lnTo>
                <a:lnTo>
                  <a:pt x="3810" y="72390"/>
                </a:lnTo>
                <a:lnTo>
                  <a:pt x="0" y="99060"/>
                </a:lnTo>
                <a:lnTo>
                  <a:pt x="0" y="133350"/>
                </a:lnTo>
                <a:lnTo>
                  <a:pt x="3810" y="163830"/>
                </a:lnTo>
                <a:lnTo>
                  <a:pt x="15240" y="213360"/>
                </a:lnTo>
                <a:lnTo>
                  <a:pt x="30480" y="251460"/>
                </a:lnTo>
                <a:lnTo>
                  <a:pt x="49530" y="289560"/>
                </a:lnTo>
                <a:lnTo>
                  <a:pt x="87630" y="300990"/>
                </a:lnTo>
                <a:lnTo>
                  <a:pt x="118110" y="304800"/>
                </a:lnTo>
                <a:lnTo>
                  <a:pt x="148590" y="316230"/>
                </a:lnTo>
                <a:lnTo>
                  <a:pt x="205740" y="327660"/>
                </a:lnTo>
                <a:lnTo>
                  <a:pt x="255270" y="331470"/>
                </a:lnTo>
                <a:lnTo>
                  <a:pt x="293370" y="327660"/>
                </a:lnTo>
                <a:lnTo>
                  <a:pt x="346710" y="278130"/>
                </a:lnTo>
                <a:lnTo>
                  <a:pt x="381000" y="236220"/>
                </a:lnTo>
                <a:lnTo>
                  <a:pt x="411480" y="201930"/>
                </a:lnTo>
                <a:lnTo>
                  <a:pt x="445770" y="160020"/>
                </a:lnTo>
                <a:lnTo>
                  <a:pt x="468630" y="129540"/>
                </a:lnTo>
                <a:lnTo>
                  <a:pt x="487680" y="99060"/>
                </a:lnTo>
                <a:lnTo>
                  <a:pt x="506730" y="68580"/>
                </a:lnTo>
                <a:lnTo>
                  <a:pt x="506730" y="15240"/>
                </a:lnTo>
                <a:close/>
              </a:path>
            </a:pathLst>
          </a:custGeom>
          <a:noFill/>
          <a:ln w="1270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Freeform 15"/>
          <p:cNvSpPr/>
          <p:nvPr/>
        </p:nvSpPr>
        <p:spPr>
          <a:xfrm>
            <a:off x="4288549" y="1807212"/>
            <a:ext cx="224710" cy="188470"/>
          </a:xfrm>
          <a:custGeom>
            <a:avLst/>
            <a:gdLst>
              <a:gd name="connsiteX0" fmla="*/ 339090 w 339090"/>
              <a:gd name="connsiteY0" fmla="*/ 15240 h 274320"/>
              <a:gd name="connsiteX1" fmla="*/ 247650 w 339090"/>
              <a:gd name="connsiteY1" fmla="*/ 3810 h 274320"/>
              <a:gd name="connsiteX2" fmla="*/ 171450 w 339090"/>
              <a:gd name="connsiteY2" fmla="*/ 3810 h 274320"/>
              <a:gd name="connsiteX3" fmla="*/ 129540 w 339090"/>
              <a:gd name="connsiteY3" fmla="*/ 0 h 274320"/>
              <a:gd name="connsiteX4" fmla="*/ 106680 w 339090"/>
              <a:gd name="connsiteY4" fmla="*/ 34290 h 274320"/>
              <a:gd name="connsiteX5" fmla="*/ 95250 w 339090"/>
              <a:gd name="connsiteY5" fmla="*/ 83820 h 274320"/>
              <a:gd name="connsiteX6" fmla="*/ 72390 w 339090"/>
              <a:gd name="connsiteY6" fmla="*/ 129540 h 274320"/>
              <a:gd name="connsiteX7" fmla="*/ 49530 w 339090"/>
              <a:gd name="connsiteY7" fmla="*/ 163830 h 274320"/>
              <a:gd name="connsiteX8" fmla="*/ 26670 w 339090"/>
              <a:gd name="connsiteY8" fmla="*/ 182880 h 274320"/>
              <a:gd name="connsiteX9" fmla="*/ 0 w 339090"/>
              <a:gd name="connsiteY9" fmla="*/ 205740 h 274320"/>
              <a:gd name="connsiteX10" fmla="*/ 22860 w 339090"/>
              <a:gd name="connsiteY10" fmla="*/ 217170 h 274320"/>
              <a:gd name="connsiteX11" fmla="*/ 60960 w 339090"/>
              <a:gd name="connsiteY11" fmla="*/ 220980 h 274320"/>
              <a:gd name="connsiteX12" fmla="*/ 114300 w 339090"/>
              <a:gd name="connsiteY12" fmla="*/ 236220 h 274320"/>
              <a:gd name="connsiteX13" fmla="*/ 160020 w 339090"/>
              <a:gd name="connsiteY13" fmla="*/ 255270 h 274320"/>
              <a:gd name="connsiteX14" fmla="*/ 205740 w 339090"/>
              <a:gd name="connsiteY14" fmla="*/ 270510 h 274320"/>
              <a:gd name="connsiteX15" fmla="*/ 240030 w 339090"/>
              <a:gd name="connsiteY15" fmla="*/ 274320 h 274320"/>
              <a:gd name="connsiteX16" fmla="*/ 278130 w 339090"/>
              <a:gd name="connsiteY16" fmla="*/ 259080 h 274320"/>
              <a:gd name="connsiteX17" fmla="*/ 297180 w 339090"/>
              <a:gd name="connsiteY17" fmla="*/ 201930 h 274320"/>
              <a:gd name="connsiteX18" fmla="*/ 320040 w 339090"/>
              <a:gd name="connsiteY18" fmla="*/ 163830 h 274320"/>
              <a:gd name="connsiteX19" fmla="*/ 331470 w 339090"/>
              <a:gd name="connsiteY19" fmla="*/ 118110 h 274320"/>
              <a:gd name="connsiteX20" fmla="*/ 339090 w 339090"/>
              <a:gd name="connsiteY20" fmla="*/ 68580 h 274320"/>
              <a:gd name="connsiteX21" fmla="*/ 339090 w 339090"/>
              <a:gd name="connsiteY21" fmla="*/ 15240 h 27432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</a:cxnLst>
            <a:rect l="l" t="t" r="r" b="b"/>
            <a:pathLst>
              <a:path w="339090" h="274320">
                <a:moveTo>
                  <a:pt x="339090" y="15240"/>
                </a:moveTo>
                <a:lnTo>
                  <a:pt x="247650" y="3810"/>
                </a:lnTo>
                <a:lnTo>
                  <a:pt x="171450" y="3810"/>
                </a:lnTo>
                <a:lnTo>
                  <a:pt x="129540" y="0"/>
                </a:lnTo>
                <a:lnTo>
                  <a:pt x="106680" y="34290"/>
                </a:lnTo>
                <a:lnTo>
                  <a:pt x="95250" y="83820"/>
                </a:lnTo>
                <a:lnTo>
                  <a:pt x="72390" y="129540"/>
                </a:lnTo>
                <a:lnTo>
                  <a:pt x="49530" y="163830"/>
                </a:lnTo>
                <a:lnTo>
                  <a:pt x="26670" y="182880"/>
                </a:lnTo>
                <a:lnTo>
                  <a:pt x="0" y="205740"/>
                </a:lnTo>
                <a:lnTo>
                  <a:pt x="22860" y="217170"/>
                </a:lnTo>
                <a:lnTo>
                  <a:pt x="60960" y="220980"/>
                </a:lnTo>
                <a:lnTo>
                  <a:pt x="114300" y="236220"/>
                </a:lnTo>
                <a:lnTo>
                  <a:pt x="160020" y="255270"/>
                </a:lnTo>
                <a:lnTo>
                  <a:pt x="205740" y="270510"/>
                </a:lnTo>
                <a:lnTo>
                  <a:pt x="240030" y="274320"/>
                </a:lnTo>
                <a:lnTo>
                  <a:pt x="278130" y="259080"/>
                </a:lnTo>
                <a:lnTo>
                  <a:pt x="297180" y="201930"/>
                </a:lnTo>
                <a:lnTo>
                  <a:pt x="320040" y="163830"/>
                </a:lnTo>
                <a:lnTo>
                  <a:pt x="331470" y="118110"/>
                </a:lnTo>
                <a:lnTo>
                  <a:pt x="339090" y="68580"/>
                </a:lnTo>
                <a:lnTo>
                  <a:pt x="339090" y="15240"/>
                </a:lnTo>
                <a:close/>
              </a:path>
            </a:pathLst>
          </a:custGeom>
          <a:noFill/>
          <a:ln w="12700">
            <a:solidFill>
              <a:srgbClr val="C0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47EAF4A-729F-4068-B564-1F258770E427}"/>
              </a:ext>
            </a:extLst>
          </p:cNvPr>
          <p:cNvSpPr txBox="1"/>
          <p:nvPr/>
        </p:nvSpPr>
        <p:spPr>
          <a:xfrm>
            <a:off x="633186" y="1123171"/>
            <a:ext cx="1260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B/PAS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BE43D55-2847-488F-A8BB-AB89DFCE9258}"/>
              </a:ext>
            </a:extLst>
          </p:cNvPr>
          <p:cNvSpPr txBox="1"/>
          <p:nvPr/>
        </p:nvSpPr>
        <p:spPr>
          <a:xfrm>
            <a:off x="1946958" y="1123171"/>
            <a:ext cx="1260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H&amp;E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Arrow: Right 12">
            <a:extLst>
              <a:ext uri="{FF2B5EF4-FFF2-40B4-BE49-F238E27FC236}">
                <a16:creationId xmlns:a16="http://schemas.microsoft.com/office/drawing/2014/main" id="{C2EB825B-3E89-4F7C-AF68-83611575F9AD}"/>
              </a:ext>
            </a:extLst>
          </p:cNvPr>
          <p:cNvSpPr/>
          <p:nvPr/>
        </p:nvSpPr>
        <p:spPr>
          <a:xfrm>
            <a:off x="4421620" y="1283715"/>
            <a:ext cx="556207" cy="921075"/>
          </a:xfrm>
          <a:prstGeom prst="rightArrow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E3D5FB1-E4DA-4785-BF53-6AA1AECE11A5}"/>
              </a:ext>
            </a:extLst>
          </p:cNvPr>
          <p:cNvSpPr txBox="1"/>
          <p:nvPr/>
        </p:nvSpPr>
        <p:spPr>
          <a:xfrm>
            <a:off x="4272306" y="1558716"/>
            <a:ext cx="7487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ucus capture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/>
          <p:cNvCxnSpPr/>
          <p:nvPr/>
        </p:nvCxnSpPr>
        <p:spPr>
          <a:xfrm>
            <a:off x="1699172" y="2179395"/>
            <a:ext cx="1398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3033132" y="2185225"/>
            <a:ext cx="1398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347806" y="1112126"/>
            <a:ext cx="4176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47805" y="2395862"/>
            <a:ext cx="4176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C520DBE-4159-5AE8-7E28-4598B5475674}"/>
              </a:ext>
            </a:extLst>
          </p:cNvPr>
          <p:cNvSpPr txBox="1"/>
          <p:nvPr/>
        </p:nvSpPr>
        <p:spPr>
          <a:xfrm rot="16200000">
            <a:off x="-103576" y="1584717"/>
            <a:ext cx="11446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ucinous Adenocarcinoma </a:t>
            </a:r>
          </a:p>
        </p:txBody>
      </p:sp>
      <p:graphicFrame>
        <p:nvGraphicFramePr>
          <p:cNvPr id="71" name="Table 7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6049481"/>
              </p:ext>
            </p:extLst>
          </p:nvPr>
        </p:nvGraphicFramePr>
        <p:xfrm>
          <a:off x="664200" y="2410837"/>
          <a:ext cx="2090017" cy="4658689"/>
        </p:xfrm>
        <a:graphic>
          <a:graphicData uri="http://schemas.openxmlformats.org/drawingml/2006/table">
            <a:tbl>
              <a:tblPr firstRow="1" bandRow="1">
                <a:tableStyleId>{793D81CF-94F2-401A-BA57-92F5A7B2D0C5}</a:tableStyleId>
              </a:tblPr>
              <a:tblGrid>
                <a:gridCol w="1394856">
                  <a:extLst>
                    <a:ext uri="{9D8B030D-6E8A-4147-A177-3AD203B41FA5}">
                      <a16:colId xmlns:a16="http://schemas.microsoft.com/office/drawing/2014/main" val="847868024"/>
                    </a:ext>
                  </a:extLst>
                </a:gridCol>
                <a:gridCol w="695161">
                  <a:extLst>
                    <a:ext uri="{9D8B030D-6E8A-4147-A177-3AD203B41FA5}">
                      <a16:colId xmlns:a16="http://schemas.microsoft.com/office/drawing/2014/main" val="2913105603"/>
                    </a:ext>
                  </a:extLst>
                </a:gridCol>
              </a:tblGrid>
              <a:tr h="454963">
                <a:tc gridSpan="2">
                  <a:txBody>
                    <a:bodyPr/>
                    <a:lstStyle/>
                    <a:p>
                      <a:pPr algn="just"/>
                      <a:r>
                        <a:rPr lang="en-GB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 10 most abundant secretome-associated proteins in mucinous adenocarcinoma mucus. (171 proteins total)</a:t>
                      </a:r>
                      <a:endParaRPr lang="en-GB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19635135"/>
                  </a:ext>
                </a:extLst>
              </a:tr>
              <a:tr h="333639">
                <a:tc>
                  <a:txBody>
                    <a:bodyPr/>
                    <a:lstStyle/>
                    <a:p>
                      <a:pPr algn="ctr"/>
                      <a:r>
                        <a:rPr lang="en-GB" sz="800" b="0" i="1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r>
                        <a:rPr lang="en-GB" sz="800" b="0" i="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GB" sz="800" b="0" i="0" u="non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rotein name</a:t>
                      </a:r>
                      <a:endParaRPr lang="en-GB" sz="800" b="0" i="0" u="non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0" i="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iBAQ (x10</a:t>
                      </a:r>
                      <a:r>
                        <a:rPr lang="en-GB" sz="800" b="0" i="0" u="non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GB" sz="800" b="0" i="0" u="non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GB" sz="800" b="0" i="0" u="non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686526446"/>
                  </a:ext>
                </a:extLst>
              </a:tr>
              <a:tr h="333639">
                <a:tc>
                  <a:txBody>
                    <a:bodyPr/>
                    <a:lstStyle/>
                    <a:p>
                      <a:pPr algn="ctr"/>
                      <a:r>
                        <a:rPr lang="en-GB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FTPA1/2</a:t>
                      </a:r>
                      <a:r>
                        <a:rPr lang="en-GB" sz="800" i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Pulmonary surfactant-associated protein A1/2</a:t>
                      </a:r>
                      <a:endParaRPr lang="en-GB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99</a:t>
                      </a:r>
                    </a:p>
                  </a:txBody>
                  <a:tcPr marL="36000" marR="3600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910339107"/>
                  </a:ext>
                </a:extLst>
              </a:tr>
              <a:tr h="307673">
                <a:tc>
                  <a:txBody>
                    <a:bodyPr/>
                    <a:lstStyle/>
                    <a:p>
                      <a:pPr algn="ctr"/>
                      <a:r>
                        <a:rPr lang="en-GB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C5AC</a:t>
                      </a: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</a:t>
                      </a:r>
                      <a:r>
                        <a:rPr lang="en-GB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ucin-5AC</a:t>
                      </a:r>
                      <a:endParaRPr lang="en-GB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97</a:t>
                      </a:r>
                    </a:p>
                  </a:txBody>
                  <a:tcPr marL="36000" marR="3600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156467066"/>
                  </a:ext>
                </a:extLst>
              </a:tr>
              <a:tr h="307673">
                <a:tc>
                  <a:txBody>
                    <a:bodyPr/>
                    <a:lstStyle/>
                    <a:p>
                      <a:pPr algn="ctr"/>
                      <a:r>
                        <a:rPr lang="en-GB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A1</a:t>
                      </a: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Apolipoprotein A-I</a:t>
                      </a:r>
                    </a:p>
                  </a:txBody>
                  <a:tcPr marL="36000" marR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76</a:t>
                      </a:r>
                    </a:p>
                  </a:txBody>
                  <a:tcPr marL="36000" marR="3600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990335174"/>
                  </a:ext>
                </a:extLst>
              </a:tr>
              <a:tr h="379323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CD</a:t>
                      </a: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Dermcidin</a:t>
                      </a:r>
                    </a:p>
                  </a:txBody>
                  <a:tcPr marL="36000" marR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96</a:t>
                      </a:r>
                    </a:p>
                  </a:txBody>
                  <a:tcPr marL="36000" marR="3600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977680452"/>
                  </a:ext>
                </a:extLst>
              </a:tr>
              <a:tr h="399787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</a:t>
                      </a: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Serotransferrin</a:t>
                      </a:r>
                    </a:p>
                  </a:txBody>
                  <a:tcPr marL="36000" marR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31</a:t>
                      </a:r>
                    </a:p>
                  </a:txBody>
                  <a:tcPr marL="36000" marR="3600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921410318"/>
                  </a:ext>
                </a:extLst>
              </a:tr>
              <a:tr h="307673">
                <a:tc>
                  <a:txBody>
                    <a:bodyPr/>
                    <a:lstStyle/>
                    <a:p>
                      <a:pPr algn="ctr"/>
                      <a:r>
                        <a:rPr lang="en-GB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FA3/1</a:t>
                      </a:r>
                      <a:r>
                        <a:rPr lang="en-GB" sz="8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Neutrophil defensin 3/1</a:t>
                      </a:r>
                      <a:endParaRPr lang="en-GB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96</a:t>
                      </a:r>
                    </a:p>
                  </a:txBody>
                  <a:tcPr marL="36000" marR="3600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144931184"/>
                  </a:ext>
                </a:extLst>
              </a:tr>
              <a:tr h="333639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PINA1</a:t>
                      </a: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Alpha-1-antitrypsin</a:t>
                      </a:r>
                    </a:p>
                    <a:p>
                      <a:pPr algn="ctr"/>
                      <a:endParaRPr lang="en-GB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01</a:t>
                      </a:r>
                    </a:p>
                  </a:txBody>
                  <a:tcPr marL="36000" marR="3600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502594510"/>
                  </a:ext>
                </a:extLst>
              </a:tr>
              <a:tr h="333639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FTPB</a:t>
                      </a: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pulmonary surfactant-associated protein B</a:t>
                      </a:r>
                    </a:p>
                  </a:txBody>
                  <a:tcPr marL="36000" marR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96</a:t>
                      </a:r>
                    </a:p>
                  </a:txBody>
                  <a:tcPr marL="36000" marR="3600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604709788"/>
                  </a:ext>
                </a:extLst>
              </a:tr>
              <a:tr h="307673">
                <a:tc>
                  <a:txBody>
                    <a:bodyPr/>
                    <a:lstStyle/>
                    <a:p>
                      <a:pPr algn="ctr"/>
                      <a:r>
                        <a:rPr lang="en-GB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C5B</a:t>
                      </a: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Mucin-5B</a:t>
                      </a:r>
                    </a:p>
                  </a:txBody>
                  <a:tcPr marL="36000" marR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2</a:t>
                      </a:r>
                    </a:p>
                  </a:txBody>
                  <a:tcPr marL="36000" marR="3600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9005432"/>
                  </a:ext>
                </a:extLst>
              </a:tr>
              <a:tr h="307673">
                <a:tc>
                  <a:txBody>
                    <a:bodyPr/>
                    <a:lstStyle/>
                    <a:p>
                      <a:pPr algn="ctr"/>
                      <a:r>
                        <a:rPr lang="en-GB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BP5</a:t>
                      </a:r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Fatty acid-binding</a:t>
                      </a:r>
                      <a:r>
                        <a:rPr lang="en-GB" sz="8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rotein</a:t>
                      </a:r>
                      <a:endParaRPr lang="en-GB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5</a:t>
                      </a:r>
                    </a:p>
                  </a:txBody>
                  <a:tcPr marL="36000" marR="3600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104048015"/>
                  </a:ext>
                </a:extLst>
              </a:tr>
            </a:tbl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FBE43D55-2847-488F-A8BB-AB89DFCE9258}"/>
              </a:ext>
            </a:extLst>
          </p:cNvPr>
          <p:cNvSpPr txBox="1"/>
          <p:nvPr/>
        </p:nvSpPr>
        <p:spPr>
          <a:xfrm>
            <a:off x="3365677" y="1123170"/>
            <a:ext cx="25979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H&amp;E – non-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coverslipped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for LCM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156768" y="2400748"/>
            <a:ext cx="4176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2312" y="2833826"/>
            <a:ext cx="3488695" cy="34886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38158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44</Words>
  <Application>Microsoft Office PowerPoint</Application>
  <PresentationFormat>Letter Paper (8.5x11 in)</PresentationFormat>
  <Paragraphs>281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Manche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remy Herrera</dc:creator>
  <cp:lastModifiedBy>Herrera, Jeremy</cp:lastModifiedBy>
  <cp:revision>34</cp:revision>
  <dcterms:created xsi:type="dcterms:W3CDTF">2022-07-20T11:45:09Z</dcterms:created>
  <dcterms:modified xsi:type="dcterms:W3CDTF">2022-11-01T15:39:19Z</dcterms:modified>
</cp:coreProperties>
</file>